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  <p:sldId id="267" r:id="rId3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2806" autoAdjust="0"/>
  </p:normalViewPr>
  <p:slideViewPr>
    <p:cSldViewPr>
      <p:cViewPr varScale="1">
        <p:scale>
          <a:sx n="46" d="100"/>
          <a:sy n="46" d="100"/>
        </p:scale>
        <p:origin x="2112" y="4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15731" y="827584"/>
            <a:ext cx="2416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Appendix Figure S8.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 descr="C:\Users\ImageQuant\Desktop\Sonomi\Fstl1\4. MI\Heart\2-15-2016 MI1W fasted 1 4-12% (2)\p-Akt ser473\p-AKt ser high 20160215_1327_6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4664" y="4705350"/>
            <a:ext cx="2535936" cy="16906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 descr="C:\Users\ImageQuant\Desktop\Sonomi\Fstl1\4. MI\Heart\2-15-2016 MI1W fasted 1 4-12% (2)\t-Akt\t-Akt 20160216_1155_3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68960" y="4705350"/>
            <a:ext cx="2644055" cy="176270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 descr="C:\Users\ImageQuant\Desktop\Sonomi\Fstl1\4. MI\Heart\2-15-2016 MI1W fasted 1 4-12% (2)\Tubulin\Tubulin standard 20160218_1435_5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4664" y="6414492"/>
            <a:ext cx="2537458" cy="16916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7" descr="C:\Users\ImageQuant\Desktop\Sonomi\Fstl1\4. MI\Heart\2-15-2016 MI1W fasted 12% (1)\p-AMPK Thr\p-AMPK standard 20160215_1330_3.tif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7166" y="1187624"/>
            <a:ext cx="2644055" cy="176270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8" descr="C:\Users\ImageQuant\Desktop\Sonomi\Fstl1\4. MI\Heart\2-15-2016 MI1W fasted 12% (1)\t-AMPK_2\t-AMPK 20160217_1226_8.tif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68960" y="1187624"/>
            <a:ext cx="2644055" cy="176270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9" descr="C:\Users\ImageQuant\Desktop\Sonomi\Fstl1\4. MI\Heart\2-15-2016 MI1W fasted 12% (1)\Tubulin\Tubulin standard 20160218_1439_5.tif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6089" y="2915816"/>
            <a:ext cx="2644055" cy="176270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正方形/長方形 22"/>
          <p:cNvSpPr/>
          <p:nvPr/>
        </p:nvSpPr>
        <p:spPr>
          <a:xfrm>
            <a:off x="1732410" y="1765195"/>
            <a:ext cx="671845" cy="295019"/>
          </a:xfrm>
          <a:prstGeom prst="rect">
            <a:avLst/>
          </a:prstGeom>
          <a:noFill/>
          <a:ln w="1270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テキスト ボックス 23"/>
          <p:cNvSpPr txBox="1"/>
          <p:nvPr/>
        </p:nvSpPr>
        <p:spPr>
          <a:xfrm>
            <a:off x="620688" y="1486689"/>
            <a:ext cx="13131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AMPK (T172) </a:t>
            </a:r>
            <a:endParaRPr 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正方形/長方形 22"/>
          <p:cNvSpPr/>
          <p:nvPr/>
        </p:nvSpPr>
        <p:spPr>
          <a:xfrm>
            <a:off x="815789" y="1765195"/>
            <a:ext cx="344763" cy="295019"/>
          </a:xfrm>
          <a:prstGeom prst="rect">
            <a:avLst/>
          </a:prstGeom>
          <a:noFill/>
          <a:ln w="1270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テキスト ボックス 23"/>
          <p:cNvSpPr txBox="1"/>
          <p:nvPr/>
        </p:nvSpPr>
        <p:spPr>
          <a:xfrm>
            <a:off x="712070" y="2062753"/>
            <a:ext cx="628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am </a:t>
            </a:r>
            <a:endParaRPr 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23"/>
          <p:cNvSpPr txBox="1"/>
          <p:nvPr/>
        </p:nvSpPr>
        <p:spPr>
          <a:xfrm>
            <a:off x="1792190" y="2051720"/>
            <a:ext cx="689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-RM </a:t>
            </a:r>
            <a:endParaRPr 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正方形/長方形 22"/>
          <p:cNvSpPr/>
          <p:nvPr/>
        </p:nvSpPr>
        <p:spPr>
          <a:xfrm>
            <a:off x="4614390" y="1754162"/>
            <a:ext cx="610768" cy="295019"/>
          </a:xfrm>
          <a:prstGeom prst="rect">
            <a:avLst/>
          </a:prstGeom>
          <a:noFill/>
          <a:ln w="1270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テキスト ボックス 23"/>
          <p:cNvSpPr txBox="1"/>
          <p:nvPr/>
        </p:nvSpPr>
        <p:spPr>
          <a:xfrm>
            <a:off x="3480756" y="1475656"/>
            <a:ext cx="6639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MPK </a:t>
            </a:r>
            <a:endParaRPr 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正方形/長方形 22"/>
          <p:cNvSpPr/>
          <p:nvPr/>
        </p:nvSpPr>
        <p:spPr>
          <a:xfrm>
            <a:off x="3675857" y="1754162"/>
            <a:ext cx="344763" cy="295019"/>
          </a:xfrm>
          <a:prstGeom prst="rect">
            <a:avLst/>
          </a:prstGeom>
          <a:noFill/>
          <a:ln w="1270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テキスト ボックス 23"/>
          <p:cNvSpPr txBox="1"/>
          <p:nvPr/>
        </p:nvSpPr>
        <p:spPr>
          <a:xfrm>
            <a:off x="3572138" y="2051720"/>
            <a:ext cx="628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am </a:t>
            </a:r>
            <a:endParaRPr 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31"/>
          <p:cNvSpPr txBox="1"/>
          <p:nvPr/>
        </p:nvSpPr>
        <p:spPr>
          <a:xfrm>
            <a:off x="4652258" y="2040687"/>
            <a:ext cx="689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-RM </a:t>
            </a:r>
            <a:endParaRPr 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正方形/長方形 22"/>
          <p:cNvSpPr/>
          <p:nvPr/>
        </p:nvSpPr>
        <p:spPr>
          <a:xfrm>
            <a:off x="1706000" y="3583240"/>
            <a:ext cx="671845" cy="295019"/>
          </a:xfrm>
          <a:prstGeom prst="rect">
            <a:avLst/>
          </a:prstGeom>
          <a:noFill/>
          <a:ln w="1270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テキスト ボックス 23"/>
          <p:cNvSpPr txBox="1"/>
          <p:nvPr/>
        </p:nvSpPr>
        <p:spPr>
          <a:xfrm>
            <a:off x="568400" y="3321986"/>
            <a:ext cx="6806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正方形/長方形 22"/>
          <p:cNvSpPr/>
          <p:nvPr/>
        </p:nvSpPr>
        <p:spPr>
          <a:xfrm>
            <a:off x="763501" y="3600492"/>
            <a:ext cx="344763" cy="295019"/>
          </a:xfrm>
          <a:prstGeom prst="rect">
            <a:avLst/>
          </a:prstGeom>
          <a:noFill/>
          <a:ln w="1270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テキスト ボックス 23"/>
          <p:cNvSpPr txBox="1"/>
          <p:nvPr/>
        </p:nvSpPr>
        <p:spPr>
          <a:xfrm>
            <a:off x="659782" y="3898050"/>
            <a:ext cx="628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am </a:t>
            </a:r>
            <a:endParaRPr 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36"/>
          <p:cNvSpPr txBox="1"/>
          <p:nvPr/>
        </p:nvSpPr>
        <p:spPr>
          <a:xfrm>
            <a:off x="1739902" y="3887017"/>
            <a:ext cx="689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-RM </a:t>
            </a:r>
            <a:endParaRPr 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正方形/長方形 22"/>
          <p:cNvSpPr/>
          <p:nvPr/>
        </p:nvSpPr>
        <p:spPr>
          <a:xfrm>
            <a:off x="1831266" y="5276335"/>
            <a:ext cx="610768" cy="295019"/>
          </a:xfrm>
          <a:prstGeom prst="rect">
            <a:avLst/>
          </a:prstGeom>
          <a:noFill/>
          <a:ln w="1270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テキスト ボックス 23"/>
          <p:cNvSpPr txBox="1"/>
          <p:nvPr/>
        </p:nvSpPr>
        <p:spPr>
          <a:xfrm>
            <a:off x="694069" y="5015081"/>
            <a:ext cx="12009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</a:t>
            </a:r>
            <a:r>
              <a:rPr lang="en-US" sz="12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r>
              <a:rPr lang="en-US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Ser473)</a:t>
            </a:r>
            <a:endParaRPr 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正方形/長方形 22"/>
          <p:cNvSpPr/>
          <p:nvPr/>
        </p:nvSpPr>
        <p:spPr>
          <a:xfrm>
            <a:off x="873900" y="5293587"/>
            <a:ext cx="313421" cy="295019"/>
          </a:xfrm>
          <a:prstGeom prst="rect">
            <a:avLst/>
          </a:prstGeom>
          <a:noFill/>
          <a:ln w="1270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テキスト ボックス 23"/>
          <p:cNvSpPr txBox="1"/>
          <p:nvPr/>
        </p:nvSpPr>
        <p:spPr>
          <a:xfrm>
            <a:off x="783087" y="5591145"/>
            <a:ext cx="571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am </a:t>
            </a:r>
            <a:endParaRPr 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41"/>
          <p:cNvSpPr txBox="1"/>
          <p:nvPr/>
        </p:nvSpPr>
        <p:spPr>
          <a:xfrm>
            <a:off x="1865976" y="5580112"/>
            <a:ext cx="6269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-RM </a:t>
            </a:r>
            <a:endParaRPr 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正方形/長方形 22"/>
          <p:cNvSpPr/>
          <p:nvPr/>
        </p:nvSpPr>
        <p:spPr>
          <a:xfrm>
            <a:off x="4605074" y="5348343"/>
            <a:ext cx="610768" cy="295019"/>
          </a:xfrm>
          <a:prstGeom prst="rect">
            <a:avLst/>
          </a:prstGeom>
          <a:noFill/>
          <a:ln w="1270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テキスト ボックス 23"/>
          <p:cNvSpPr txBox="1"/>
          <p:nvPr/>
        </p:nvSpPr>
        <p:spPr>
          <a:xfrm>
            <a:off x="3467877" y="5087089"/>
            <a:ext cx="4507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r>
              <a:rPr lang="en-US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正方形/長方形 22"/>
          <p:cNvSpPr/>
          <p:nvPr/>
        </p:nvSpPr>
        <p:spPr>
          <a:xfrm>
            <a:off x="3647708" y="5365595"/>
            <a:ext cx="313421" cy="295019"/>
          </a:xfrm>
          <a:prstGeom prst="rect">
            <a:avLst/>
          </a:prstGeom>
          <a:noFill/>
          <a:ln w="1270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テキスト ボックス 23"/>
          <p:cNvSpPr txBox="1"/>
          <p:nvPr/>
        </p:nvSpPr>
        <p:spPr>
          <a:xfrm>
            <a:off x="3556895" y="5663153"/>
            <a:ext cx="571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am </a:t>
            </a:r>
            <a:endParaRPr 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46"/>
          <p:cNvSpPr txBox="1"/>
          <p:nvPr/>
        </p:nvSpPr>
        <p:spPr>
          <a:xfrm>
            <a:off x="4639784" y="5652120"/>
            <a:ext cx="6269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-RM </a:t>
            </a:r>
            <a:endParaRPr 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正方形/長方形 22"/>
          <p:cNvSpPr/>
          <p:nvPr/>
        </p:nvSpPr>
        <p:spPr>
          <a:xfrm>
            <a:off x="1714755" y="7004527"/>
            <a:ext cx="610768" cy="295019"/>
          </a:xfrm>
          <a:prstGeom prst="rect">
            <a:avLst/>
          </a:prstGeom>
          <a:noFill/>
          <a:ln w="1270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テキスト ボックス 23"/>
          <p:cNvSpPr txBox="1"/>
          <p:nvPr/>
        </p:nvSpPr>
        <p:spPr>
          <a:xfrm>
            <a:off x="577558" y="6743273"/>
            <a:ext cx="6806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正方形/長方形 22"/>
          <p:cNvSpPr/>
          <p:nvPr/>
        </p:nvSpPr>
        <p:spPr>
          <a:xfrm>
            <a:off x="774641" y="7021779"/>
            <a:ext cx="313421" cy="295019"/>
          </a:xfrm>
          <a:prstGeom prst="rect">
            <a:avLst/>
          </a:prstGeom>
          <a:noFill/>
          <a:ln w="1270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テキスト ボックス 23"/>
          <p:cNvSpPr txBox="1"/>
          <p:nvPr/>
        </p:nvSpPr>
        <p:spPr>
          <a:xfrm>
            <a:off x="666576" y="7319337"/>
            <a:ext cx="571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am </a:t>
            </a:r>
            <a:endParaRPr 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51"/>
          <p:cNvSpPr txBox="1"/>
          <p:nvPr/>
        </p:nvSpPr>
        <p:spPr>
          <a:xfrm>
            <a:off x="1749465" y="7308304"/>
            <a:ext cx="6269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-RM </a:t>
            </a:r>
            <a:endParaRPr 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039855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84149718"/>
              </p:ext>
            </p:extLst>
          </p:nvPr>
        </p:nvGraphicFramePr>
        <p:xfrm>
          <a:off x="188640" y="395537"/>
          <a:ext cx="5040558" cy="338437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79216"/>
                <a:gridCol w="560063"/>
                <a:gridCol w="779216"/>
                <a:gridCol w="974021"/>
                <a:gridCol w="974021"/>
                <a:gridCol w="974021"/>
              </a:tblGrid>
              <a:tr h="303426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Appendix Figure S8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</a:tr>
              <a:tr h="280086"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Relative intensity p-AMPK/AMPK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</a:tr>
              <a:tr h="280086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WT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sham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80086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MI-I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760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804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.232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80086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fKO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sham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056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939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671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80086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MI-I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221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114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105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80086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80086"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Relative intensity p-Akt/Ak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</a:tr>
              <a:tr h="280086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WT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sham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80086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MI-I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.597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4.777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.355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80086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fKO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sham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251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374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423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280086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MI-I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619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34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0.968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0191708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6</TotalTime>
  <Words>73</Words>
  <Application>Microsoft Office PowerPoint</Application>
  <PresentationFormat>On-screen Show (4:3)</PresentationFormat>
  <Paragraphs>5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ＭＳ Ｐゴシック</vt:lpstr>
      <vt:lpstr>Arial</vt:lpstr>
      <vt:lpstr>Calibri</vt:lpstr>
      <vt:lpstr>Office テーマ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onomi</dc:creator>
  <cp:lastModifiedBy>Whittaker, Linda D</cp:lastModifiedBy>
  <cp:revision>88</cp:revision>
  <dcterms:modified xsi:type="dcterms:W3CDTF">2016-04-22T18:49:00Z</dcterms:modified>
</cp:coreProperties>
</file>